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9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Experiments\Crystal%20violet\Colony%20AUY%202nd\Colony%202nd%20n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/>
            </a:pPr>
            <a:r>
              <a:rPr lang="en-US" sz="600"/>
              <a:t>24 h</a:t>
            </a:r>
          </a:p>
          <a:p>
            <a:pPr>
              <a:defRPr sz="600"/>
            </a:pPr>
            <a:r>
              <a:rPr lang="en-US" sz="600"/>
              <a:t>WE-68</a:t>
            </a:r>
          </a:p>
        </c:rich>
      </c:tx>
      <c:layout>
        <c:manualLayout>
          <c:xMode val="edge"/>
          <c:yMode val="edge"/>
          <c:x val="0.25813602193907015"/>
          <c:y val="0.64502598939838407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5562358731006091"/>
          <c:y val="6.1111111111111109E-2"/>
          <c:w val="0.65671920992138111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46:$H$4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6.24736431019975</c:v>
                  </c:pt>
                  <c:pt idx="2">
                    <c:v>6.8074821566909023</c:v>
                  </c:pt>
                  <c:pt idx="3">
                    <c:v>1.7520507256301789</c:v>
                  </c:pt>
                </c:numCache>
              </c:numRef>
            </c:plus>
            <c:minus>
              <c:numRef>
                <c:f>Sheet1!$H$46:$H$4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6.24736431019975</c:v>
                  </c:pt>
                  <c:pt idx="2">
                    <c:v>6.8074821566909023</c:v>
                  </c:pt>
                  <c:pt idx="3">
                    <c:v>1.7520507256301789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G$46:$G$49</c:f>
              <c:numCache>
                <c:formatCode>0.000</c:formatCode>
                <c:ptCount val="4"/>
                <c:pt idx="0">
                  <c:v>100</c:v>
                </c:pt>
                <c:pt idx="1">
                  <c:v>85.302657143742849</c:v>
                </c:pt>
                <c:pt idx="2">
                  <c:v>60.241704857661489</c:v>
                </c:pt>
                <c:pt idx="3">
                  <c:v>58.31672548970100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5F1-47C1-8111-EE95ACEFDE0F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50:$H$53</c:f>
                <c:numCache>
                  <c:formatCode>General</c:formatCode>
                  <c:ptCount val="4"/>
                  <c:pt idx="0">
                    <c:v>5.3827322198251135</c:v>
                  </c:pt>
                  <c:pt idx="1">
                    <c:v>9.9573445233279063</c:v>
                  </c:pt>
                  <c:pt idx="2">
                    <c:v>4.0626574100546362</c:v>
                  </c:pt>
                  <c:pt idx="3">
                    <c:v>3.1091074817374635</c:v>
                  </c:pt>
                </c:numCache>
              </c:numRef>
            </c:plus>
            <c:minus>
              <c:numRef>
                <c:f>Sheet1!$H$50:$H$53</c:f>
                <c:numCache>
                  <c:formatCode>General</c:formatCode>
                  <c:ptCount val="4"/>
                  <c:pt idx="0">
                    <c:v>5.3827322198251135</c:v>
                  </c:pt>
                  <c:pt idx="1">
                    <c:v>9.9573445233279063</c:v>
                  </c:pt>
                  <c:pt idx="2">
                    <c:v>4.0626574100546362</c:v>
                  </c:pt>
                  <c:pt idx="3">
                    <c:v>3.1091074817374635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G$50:$G$53</c:f>
              <c:numCache>
                <c:formatCode>0.000</c:formatCode>
                <c:ptCount val="4"/>
                <c:pt idx="0">
                  <c:v>68.455972493203475</c:v>
                </c:pt>
                <c:pt idx="1">
                  <c:v>69.357932423997937</c:v>
                </c:pt>
                <c:pt idx="2">
                  <c:v>56.023193585853768</c:v>
                </c:pt>
                <c:pt idx="3">
                  <c:v>57.0031479250873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5F1-47C1-8111-EE95ACEFDE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560320"/>
        <c:axId val="37562240"/>
      </c:scatterChart>
      <c:valAx>
        <c:axId val="37560320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562240"/>
        <c:crosses val="autoZero"/>
        <c:crossBetween val="midCat"/>
        <c:majorUnit val="15"/>
        <c:minorUnit val="4"/>
      </c:valAx>
      <c:valAx>
        <c:axId val="37562240"/>
        <c:scaling>
          <c:orientation val="minMax"/>
          <c:max val="2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560320"/>
        <c:crosses val="autoZero"/>
        <c:crossBetween val="midCat"/>
        <c:majorUnit val="5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/>
            </a:pPr>
            <a:r>
              <a:rPr lang="en-US" sz="600"/>
              <a:t>48 h</a:t>
            </a:r>
          </a:p>
        </c:rich>
      </c:tx>
      <c:layout>
        <c:manualLayout>
          <c:xMode val="edge"/>
          <c:yMode val="edge"/>
          <c:x val="0.24498898431410535"/>
          <c:y val="0.69893318022747164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4948490813648291"/>
          <c:y val="6.1111111111111109E-2"/>
          <c:w val="0.67794564741907259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46:$Q$49</c:f>
                <c:numCache>
                  <c:formatCode>General</c:formatCode>
                  <c:ptCount val="4"/>
                  <c:pt idx="0">
                    <c:v>104.09699521210854</c:v>
                  </c:pt>
                  <c:pt idx="1">
                    <c:v>89.159488852496253</c:v>
                  </c:pt>
                  <c:pt idx="2">
                    <c:v>23.381701953235048</c:v>
                  </c:pt>
                  <c:pt idx="3">
                    <c:v>18.968594704205096</c:v>
                  </c:pt>
                </c:numCache>
              </c:numRef>
            </c:plus>
            <c:minus>
              <c:numRef>
                <c:f>Sheet1!$Q$46:$Q$49</c:f>
                <c:numCache>
                  <c:formatCode>General</c:formatCode>
                  <c:ptCount val="4"/>
                  <c:pt idx="0">
                    <c:v>104.09699521210854</c:v>
                  </c:pt>
                  <c:pt idx="1">
                    <c:v>89.159488852496253</c:v>
                  </c:pt>
                  <c:pt idx="2">
                    <c:v>23.381701953235048</c:v>
                  </c:pt>
                  <c:pt idx="3">
                    <c:v>18.968594704205096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P$46:$P$49</c:f>
              <c:numCache>
                <c:formatCode>0.000</c:formatCode>
                <c:ptCount val="4"/>
                <c:pt idx="0">
                  <c:v>239.74304723222107</c:v>
                </c:pt>
                <c:pt idx="1">
                  <c:v>127.38465200786477</c:v>
                </c:pt>
                <c:pt idx="2">
                  <c:v>47.365756780534262</c:v>
                </c:pt>
                <c:pt idx="3">
                  <c:v>37.60739390868359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159-4B0A-B73D-4334B267AB91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50:$Q$53</c:f>
                <c:numCache>
                  <c:formatCode>General</c:formatCode>
                  <c:ptCount val="4"/>
                  <c:pt idx="0">
                    <c:v>43.584656048425344</c:v>
                  </c:pt>
                  <c:pt idx="1">
                    <c:v>32.517737738681006</c:v>
                  </c:pt>
                  <c:pt idx="2">
                    <c:v>23.071679617089355</c:v>
                  </c:pt>
                  <c:pt idx="3">
                    <c:v>18.514489432331114</c:v>
                  </c:pt>
                </c:numCache>
              </c:numRef>
            </c:plus>
            <c:minus>
              <c:numRef>
                <c:f>Sheet1!$Q$50:$Q$53</c:f>
                <c:numCache>
                  <c:formatCode>General</c:formatCode>
                  <c:ptCount val="4"/>
                  <c:pt idx="0">
                    <c:v>43.584656048425344</c:v>
                  </c:pt>
                  <c:pt idx="1">
                    <c:v>32.517737738681006</c:v>
                  </c:pt>
                  <c:pt idx="2">
                    <c:v>23.071679617089355</c:v>
                  </c:pt>
                  <c:pt idx="3">
                    <c:v>18.514489432331114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P$50:$P$53</c:f>
              <c:numCache>
                <c:formatCode>0.000</c:formatCode>
                <c:ptCount val="4"/>
                <c:pt idx="0">
                  <c:v>86.335428119316404</c:v>
                </c:pt>
                <c:pt idx="1">
                  <c:v>57.464915486924774</c:v>
                </c:pt>
                <c:pt idx="2">
                  <c:v>41.728493460358415</c:v>
                </c:pt>
                <c:pt idx="3">
                  <c:v>35.41933226016780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159-4B0A-B73D-4334B267A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581184"/>
        <c:axId val="37583104"/>
      </c:scatterChart>
      <c:valAx>
        <c:axId val="37581184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583104"/>
        <c:crosses val="autoZero"/>
        <c:crossBetween val="midCat"/>
        <c:majorUnit val="15"/>
        <c:minorUnit val="4"/>
      </c:valAx>
      <c:valAx>
        <c:axId val="37583104"/>
        <c:scaling>
          <c:orientation val="minMax"/>
          <c:max val="4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581184"/>
        <c:crosses val="autoZero"/>
        <c:crossBetween val="midCat"/>
        <c:majorUnit val="10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/>
            </a:pPr>
            <a:r>
              <a:rPr lang="en-US" sz="600"/>
              <a:t>72 h</a:t>
            </a:r>
          </a:p>
        </c:rich>
      </c:tx>
      <c:layout>
        <c:manualLayout>
          <c:xMode val="edge"/>
          <c:yMode val="edge"/>
          <c:x val="0.23934485459722712"/>
          <c:y val="0.55175428439092167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4948490813648291"/>
          <c:y val="6.1111111111111109E-2"/>
          <c:w val="0.67794564741907259"/>
          <c:h val="0.72524059492563431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Z$46:$Z$49</c:f>
                <c:numCache>
                  <c:formatCode>General</c:formatCode>
                  <c:ptCount val="4"/>
                  <c:pt idx="0">
                    <c:v>226.07144736036219</c:v>
                  </c:pt>
                  <c:pt idx="1">
                    <c:v>180.96808813813462</c:v>
                  </c:pt>
                  <c:pt idx="2">
                    <c:v>20.98627771751103</c:v>
                  </c:pt>
                  <c:pt idx="3">
                    <c:v>17.785021473104504</c:v>
                  </c:pt>
                </c:numCache>
              </c:numRef>
            </c:plus>
            <c:minus>
              <c:numRef>
                <c:f>Sheet1!$Z$46:$Z$49</c:f>
                <c:numCache>
                  <c:formatCode>General</c:formatCode>
                  <c:ptCount val="4"/>
                  <c:pt idx="0">
                    <c:v>226.07144736036219</c:v>
                  </c:pt>
                  <c:pt idx="1">
                    <c:v>180.96808813813462</c:v>
                  </c:pt>
                  <c:pt idx="2">
                    <c:v>20.98627771751103</c:v>
                  </c:pt>
                  <c:pt idx="3">
                    <c:v>17.785021473104504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Y$46:$Y$49</c:f>
              <c:numCache>
                <c:formatCode>0.000</c:formatCode>
                <c:ptCount val="4"/>
                <c:pt idx="0">
                  <c:v>531.45005779174357</c:v>
                </c:pt>
                <c:pt idx="1">
                  <c:v>261.99745543363974</c:v>
                </c:pt>
                <c:pt idx="2">
                  <c:v>40.051331001272914</c:v>
                </c:pt>
                <c:pt idx="3">
                  <c:v>38.2326638028611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88B-4036-8554-057156322826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Z$50:$Z$53</c:f>
                <c:numCache>
                  <c:formatCode>General</c:formatCode>
                  <c:ptCount val="4"/>
                  <c:pt idx="0">
                    <c:v>29.373397321934299</c:v>
                  </c:pt>
                  <c:pt idx="1">
                    <c:v>38.319738732147364</c:v>
                  </c:pt>
                  <c:pt idx="2">
                    <c:v>16.907267008384409</c:v>
                  </c:pt>
                  <c:pt idx="3">
                    <c:v>16.286008875980869</c:v>
                  </c:pt>
                </c:numCache>
              </c:numRef>
            </c:plus>
            <c:minus>
              <c:numRef>
                <c:f>Sheet1!$Z$50:$Z$53</c:f>
                <c:numCache>
                  <c:formatCode>General</c:formatCode>
                  <c:ptCount val="4"/>
                  <c:pt idx="0">
                    <c:v>29.373397321934299</c:v>
                  </c:pt>
                  <c:pt idx="1">
                    <c:v>38.319738732147364</c:v>
                  </c:pt>
                  <c:pt idx="2">
                    <c:v>16.907267008384409</c:v>
                  </c:pt>
                  <c:pt idx="3">
                    <c:v>16.286008875980869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Y$50:$Y$53</c:f>
              <c:numCache>
                <c:formatCode>0.000</c:formatCode>
                <c:ptCount val="4"/>
                <c:pt idx="0">
                  <c:v>104.88731828987964</c:v>
                </c:pt>
                <c:pt idx="1">
                  <c:v>65.21658966229748</c:v>
                </c:pt>
                <c:pt idx="2">
                  <c:v>46.586746417495654</c:v>
                </c:pt>
                <c:pt idx="3">
                  <c:v>33.8421260040536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88B-4036-8554-0571563228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18432"/>
        <c:axId val="37620352"/>
      </c:scatterChart>
      <c:valAx>
        <c:axId val="37618432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20352"/>
        <c:crosses val="autoZero"/>
        <c:crossBetween val="midCat"/>
        <c:majorUnit val="15"/>
        <c:minorUnit val="4"/>
      </c:valAx>
      <c:valAx>
        <c:axId val="37620352"/>
        <c:scaling>
          <c:orientation val="minMax"/>
          <c:max val="8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18432"/>
        <c:crosses val="autoZero"/>
        <c:crossBetween val="midCat"/>
        <c:majorUnit val="20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 b="0"/>
            </a:pPr>
            <a:r>
              <a:rPr lang="en-US" sz="600" b="0"/>
              <a:t>24h</a:t>
            </a:r>
          </a:p>
          <a:p>
            <a:pPr>
              <a:defRPr sz="600" b="0"/>
            </a:pPr>
            <a:r>
              <a:rPr lang="en-US" sz="600" b="0"/>
              <a:t>A673</a:t>
            </a:r>
          </a:p>
        </c:rich>
      </c:tx>
      <c:layout>
        <c:manualLayout>
          <c:xMode val="edge"/>
          <c:yMode val="edge"/>
          <c:x val="0.25119495479731702"/>
          <c:y val="0.65067418043332825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3793452901720619"/>
          <c:y val="6.1111111111111109E-2"/>
          <c:w val="0.67563065033537462"/>
          <c:h val="0.74335653695461978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9:$H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5291551135797024</c:v>
                  </c:pt>
                  <c:pt idx="2">
                    <c:v>0.30985718610762886</c:v>
                  </c:pt>
                  <c:pt idx="3">
                    <c:v>0.62619178435049661</c:v>
                  </c:pt>
                </c:numCache>
              </c:numRef>
            </c:plus>
            <c:minus>
              <c:numRef>
                <c:f>Sheet1!$H$19:$H$2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4.5291551135797024</c:v>
                  </c:pt>
                  <c:pt idx="2">
                    <c:v>0.30985718610762886</c:v>
                  </c:pt>
                  <c:pt idx="3">
                    <c:v>0.62619178435049661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G$19:$G$22</c:f>
              <c:numCache>
                <c:formatCode>0.000</c:formatCode>
                <c:ptCount val="4"/>
                <c:pt idx="0">
                  <c:v>100</c:v>
                </c:pt>
                <c:pt idx="1">
                  <c:v>91.890826274839171</c:v>
                </c:pt>
                <c:pt idx="2">
                  <c:v>87.846297285694376</c:v>
                </c:pt>
                <c:pt idx="3">
                  <c:v>86.7938438519061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1E7-4EAA-B85B-B22BE5E46CD8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23:$H$26</c:f>
                <c:numCache>
                  <c:formatCode>General</c:formatCode>
                  <c:ptCount val="4"/>
                  <c:pt idx="0">
                    <c:v>3.2343432253338564</c:v>
                  </c:pt>
                  <c:pt idx="1">
                    <c:v>2.8270510977457732</c:v>
                  </c:pt>
                  <c:pt idx="2">
                    <c:v>2.7216048473067498</c:v>
                  </c:pt>
                  <c:pt idx="3">
                    <c:v>2.8942452508619807</c:v>
                  </c:pt>
                </c:numCache>
              </c:numRef>
            </c:plus>
            <c:minus>
              <c:numRef>
                <c:f>Sheet1!$H$23:$H$26</c:f>
                <c:numCache>
                  <c:formatCode>General</c:formatCode>
                  <c:ptCount val="4"/>
                  <c:pt idx="0">
                    <c:v>3.2343432253338564</c:v>
                  </c:pt>
                  <c:pt idx="1">
                    <c:v>2.8270510977457732</c:v>
                  </c:pt>
                  <c:pt idx="2">
                    <c:v>2.7216048473067498</c:v>
                  </c:pt>
                  <c:pt idx="3">
                    <c:v>2.8942452508619807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G$23:$G$26</c:f>
              <c:numCache>
                <c:formatCode>0.000</c:formatCode>
                <c:ptCount val="4"/>
                <c:pt idx="0">
                  <c:v>98.528980158043694</c:v>
                </c:pt>
                <c:pt idx="1">
                  <c:v>90.46126854818236</c:v>
                </c:pt>
                <c:pt idx="2">
                  <c:v>83.727062066927544</c:v>
                </c:pt>
                <c:pt idx="3">
                  <c:v>72.7420486059815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1E7-4EAA-B85B-B22BE5E46C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39296"/>
        <c:axId val="37641216"/>
      </c:scatterChart>
      <c:valAx>
        <c:axId val="37639296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41216"/>
        <c:crosses val="autoZero"/>
        <c:crossBetween val="midCat"/>
        <c:majorUnit val="15"/>
        <c:minorUnit val="4"/>
      </c:valAx>
      <c:valAx>
        <c:axId val="37641216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39296"/>
        <c:crosses val="autoZero"/>
        <c:crossBetween val="midCat"/>
        <c:majorUnit val="5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/>
            </a:pPr>
            <a:r>
              <a:rPr lang="en-US" sz="600"/>
              <a:t>72h</a:t>
            </a:r>
          </a:p>
        </c:rich>
      </c:tx>
      <c:layout>
        <c:manualLayout>
          <c:xMode val="edge"/>
          <c:yMode val="edge"/>
          <c:x val="0.25324455611499486"/>
          <c:y val="0.71779144794400696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4254046369203847"/>
          <c:y val="6.1111111111111109E-2"/>
          <c:w val="0.68489009186351701"/>
          <c:h val="0.74939518429761498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Z$19:$Z$22</c:f>
                <c:numCache>
                  <c:formatCode>General</c:formatCode>
                  <c:ptCount val="4"/>
                  <c:pt idx="0">
                    <c:v>91.627333491659087</c:v>
                  </c:pt>
                  <c:pt idx="1">
                    <c:v>46.414000980499111</c:v>
                  </c:pt>
                  <c:pt idx="2">
                    <c:v>21.582714043519577</c:v>
                  </c:pt>
                  <c:pt idx="3">
                    <c:v>25.167628983783079</c:v>
                  </c:pt>
                </c:numCache>
              </c:numRef>
            </c:plus>
            <c:minus>
              <c:numRef>
                <c:f>Sheet1!$Z$23:$Z$26</c:f>
                <c:numCache>
                  <c:formatCode>General</c:formatCode>
                  <c:ptCount val="4"/>
                  <c:pt idx="0">
                    <c:v>44.985355413427911</c:v>
                  </c:pt>
                  <c:pt idx="1">
                    <c:v>33.631086280905734</c:v>
                  </c:pt>
                  <c:pt idx="2">
                    <c:v>24.365075081087664</c:v>
                  </c:pt>
                  <c:pt idx="3">
                    <c:v>21.586649203055988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Y$19:$Y$22</c:f>
              <c:numCache>
                <c:formatCode>0.000</c:formatCode>
                <c:ptCount val="4"/>
                <c:pt idx="0">
                  <c:v>331.06495945763578</c:v>
                </c:pt>
                <c:pt idx="1">
                  <c:v>135.29381645038657</c:v>
                </c:pt>
                <c:pt idx="2">
                  <c:v>103.28016210618698</c:v>
                </c:pt>
                <c:pt idx="3">
                  <c:v>95.09260574966879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93B-43FA-82E9-3F0A925D5F00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Z$15:$Z$18</c:f>
                <c:numCache>
                  <c:formatCode>General</c:formatCode>
                  <c:ptCount val="4"/>
                  <c:pt idx="0">
                    <c:v>127.12351225388139</c:v>
                  </c:pt>
                  <c:pt idx="1">
                    <c:v>39.398282025082757</c:v>
                  </c:pt>
                  <c:pt idx="2">
                    <c:v>32.587466796183932</c:v>
                  </c:pt>
                  <c:pt idx="3">
                    <c:v>40.567238866877382</c:v>
                  </c:pt>
                </c:numCache>
              </c:numRef>
            </c:plus>
            <c:minus>
              <c:numRef>
                <c:f>Sheet1!$Z$15:$Z$18</c:f>
                <c:numCache>
                  <c:formatCode>General</c:formatCode>
                  <c:ptCount val="4"/>
                  <c:pt idx="0">
                    <c:v>127.12351225388139</c:v>
                  </c:pt>
                  <c:pt idx="1">
                    <c:v>39.398282025082757</c:v>
                  </c:pt>
                  <c:pt idx="2">
                    <c:v>32.587466796183932</c:v>
                  </c:pt>
                  <c:pt idx="3">
                    <c:v>40.567238866877382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Y$23:$Y$26</c:f>
              <c:numCache>
                <c:formatCode>0.000</c:formatCode>
                <c:ptCount val="4"/>
                <c:pt idx="0">
                  <c:v>204.63210585218329</c:v>
                </c:pt>
                <c:pt idx="1">
                  <c:v>103.98717034621039</c:v>
                </c:pt>
                <c:pt idx="2">
                  <c:v>101.49113156715312</c:v>
                </c:pt>
                <c:pt idx="3">
                  <c:v>99.90280430627852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93B-43FA-82E9-3F0A925D5F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63872"/>
        <c:axId val="37665792"/>
      </c:scatterChart>
      <c:valAx>
        <c:axId val="37663872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65792"/>
        <c:crosses val="autoZero"/>
        <c:crossBetween val="midCat"/>
        <c:majorUnit val="15"/>
        <c:minorUnit val="4"/>
      </c:valAx>
      <c:valAx>
        <c:axId val="37665792"/>
        <c:scaling>
          <c:orientation val="minMax"/>
          <c:max val="6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63872"/>
        <c:crosses val="autoZero"/>
        <c:crossBetween val="midCat"/>
        <c:majorUnit val="20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600"/>
            </a:pPr>
            <a:r>
              <a:rPr lang="en-US" sz="600"/>
              <a:t>48h</a:t>
            </a:r>
          </a:p>
        </c:rich>
      </c:tx>
      <c:layout>
        <c:manualLayout>
          <c:xMode val="edge"/>
          <c:yMode val="edge"/>
          <c:x val="0.24762909834730665"/>
          <c:y val="0.7144701443569553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4254046369203847"/>
          <c:y val="6.1111111111111109E-2"/>
          <c:w val="0.68489009186351701"/>
          <c:h val="0.73731788961162459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19:$Q$22</c:f>
                <c:numCache>
                  <c:formatCode>General</c:formatCode>
                  <c:ptCount val="4"/>
                  <c:pt idx="0">
                    <c:v>64.051719576765677</c:v>
                  </c:pt>
                  <c:pt idx="1">
                    <c:v>54.202748215132551</c:v>
                  </c:pt>
                  <c:pt idx="2">
                    <c:v>29.759593412276839</c:v>
                  </c:pt>
                  <c:pt idx="3">
                    <c:v>39.389101119592404</c:v>
                  </c:pt>
                </c:numCache>
              </c:numRef>
            </c:plus>
            <c:minus>
              <c:numRef>
                <c:f>Sheet1!$Q$19:$Q$22</c:f>
                <c:numCache>
                  <c:formatCode>General</c:formatCode>
                  <c:ptCount val="4"/>
                  <c:pt idx="0">
                    <c:v>64.051719576765677</c:v>
                  </c:pt>
                  <c:pt idx="1">
                    <c:v>54.202748215132551</c:v>
                  </c:pt>
                  <c:pt idx="2">
                    <c:v>29.759593412276839</c:v>
                  </c:pt>
                  <c:pt idx="3">
                    <c:v>39.389101119592404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P$19:$P$22</c:f>
              <c:numCache>
                <c:formatCode>0.000</c:formatCode>
                <c:ptCount val="4"/>
                <c:pt idx="0">
                  <c:v>172.45749049714757</c:v>
                </c:pt>
                <c:pt idx="1">
                  <c:v>116.41342854803339</c:v>
                </c:pt>
                <c:pt idx="2">
                  <c:v>91.478345636651781</c:v>
                </c:pt>
                <c:pt idx="3">
                  <c:v>103.3271878557533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ED0-476C-BE2D-98A989F96DF9}"/>
            </c:ext>
          </c:extLst>
        </c:ser>
        <c:ser>
          <c:idx val="1"/>
          <c:order val="1"/>
          <c:tx>
            <c:v>5 µM VE821</c:v>
          </c:tx>
          <c:spPr>
            <a:ln w="9525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23:$Q$26</c:f>
                <c:numCache>
                  <c:formatCode>General</c:formatCode>
                  <c:ptCount val="4"/>
                  <c:pt idx="0">
                    <c:v>59.358622075330153</c:v>
                  </c:pt>
                  <c:pt idx="1">
                    <c:v>45.468527035818418</c:v>
                  </c:pt>
                  <c:pt idx="2">
                    <c:v>33.710142556729778</c:v>
                  </c:pt>
                  <c:pt idx="3">
                    <c:v>30.317746723382701</c:v>
                  </c:pt>
                </c:numCache>
              </c:numRef>
            </c:plus>
            <c:minus>
              <c:numRef>
                <c:f>Sheet1!$Q$23:$Q$26</c:f>
                <c:numCache>
                  <c:formatCode>General</c:formatCode>
                  <c:ptCount val="4"/>
                  <c:pt idx="0">
                    <c:v>59.358622075330153</c:v>
                  </c:pt>
                  <c:pt idx="1">
                    <c:v>45.468527035818418</c:v>
                  </c:pt>
                  <c:pt idx="2">
                    <c:v>33.710142556729778</c:v>
                  </c:pt>
                  <c:pt idx="3">
                    <c:v>30.317746723382701</c:v>
                  </c:pt>
                </c:numCache>
              </c:numRef>
            </c:minus>
          </c:errBars>
          <c:xVal>
            <c:numRef>
              <c:f>Sheet1!$T$3:$T$6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45</c:v>
                </c:pt>
              </c:numCache>
            </c:numRef>
          </c:xVal>
          <c:yVal>
            <c:numRef>
              <c:f>Sheet1!$P$23:$P$26</c:f>
              <c:numCache>
                <c:formatCode>0.000</c:formatCode>
                <c:ptCount val="4"/>
                <c:pt idx="0">
                  <c:v>151.63934509363156</c:v>
                </c:pt>
                <c:pt idx="1">
                  <c:v>109.24023770815008</c:v>
                </c:pt>
                <c:pt idx="2">
                  <c:v>92.885935450995092</c:v>
                </c:pt>
                <c:pt idx="3">
                  <c:v>81.5913715889851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ED0-476C-BE2D-98A989F96D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88832"/>
        <c:axId val="37690752"/>
      </c:scatterChart>
      <c:valAx>
        <c:axId val="37688832"/>
        <c:scaling>
          <c:orientation val="minMax"/>
          <c:max val="4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UY922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90752"/>
        <c:crosses val="autoZero"/>
        <c:crossBetween val="midCat"/>
        <c:majorUnit val="15"/>
        <c:minorUnit val="4"/>
      </c:valAx>
      <c:valAx>
        <c:axId val="37690752"/>
        <c:scaling>
          <c:orientation val="minMax"/>
          <c:max val="3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ell density (% to control)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7688832"/>
        <c:crosses val="autoZero"/>
        <c:crossBetween val="midCat"/>
        <c:majorUnit val="100"/>
        <c:minorUnit val="0.1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microsoft.com/office/2007/relationships/hdphoto" Target="../media/hdphoto3.wdp"/><Relationship Id="rId18" Type="http://schemas.openxmlformats.org/officeDocument/2006/relationships/image" Target="../media/image6.jpe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image" Target="../media/image3.png"/><Relationship Id="rId17" Type="http://schemas.microsoft.com/office/2007/relationships/hdphoto" Target="../media/hdphoto5.wdp"/><Relationship Id="rId2" Type="http://schemas.openxmlformats.org/officeDocument/2006/relationships/chart" Target="../charts/chart1.xml"/><Relationship Id="rId16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microsoft.com/office/2007/relationships/hdphoto" Target="../media/hdphoto2.wdp"/><Relationship Id="rId5" Type="http://schemas.openxmlformats.org/officeDocument/2006/relationships/chart" Target="../charts/chart4.xml"/><Relationship Id="rId15" Type="http://schemas.microsoft.com/office/2007/relationships/hdphoto" Target="../media/hdphoto4.wdp"/><Relationship Id="rId10" Type="http://schemas.openxmlformats.org/officeDocument/2006/relationships/image" Target="../media/image2.png"/><Relationship Id="rId4" Type="http://schemas.openxmlformats.org/officeDocument/2006/relationships/chart" Target="../charts/chart3.xml"/><Relationship Id="rId9" Type="http://schemas.microsoft.com/office/2007/relationships/hdphoto" Target="../media/hdphoto1.wdp"/><Relationship Id="rId1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/>
          <p:cNvGrpSpPr/>
          <p:nvPr/>
        </p:nvGrpSpPr>
        <p:grpSpPr>
          <a:xfrm>
            <a:off x="400183" y="1448034"/>
            <a:ext cx="1415731" cy="1554480"/>
            <a:chOff x="485310" y="2696727"/>
            <a:chExt cx="1914338" cy="2103120"/>
          </a:xfrm>
        </p:grpSpPr>
        <p:graphicFrame>
          <p:nvGraphicFramePr>
            <p:cNvPr id="54" name="Chart 5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2756677"/>
                </p:ext>
              </p:extLst>
            </p:nvPr>
          </p:nvGraphicFramePr>
          <p:xfrm>
            <a:off x="485310" y="2696727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5" name="TextBox 54"/>
            <p:cNvSpPr txBox="1"/>
            <p:nvPr/>
          </p:nvSpPr>
          <p:spPr>
            <a:xfrm>
              <a:off x="1172366" y="3320112"/>
              <a:ext cx="427445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555636" y="3580234"/>
              <a:ext cx="427445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972203" y="3664599"/>
              <a:ext cx="427445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852465" y="3369961"/>
              <a:ext cx="332072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1819769" y="1447800"/>
            <a:ext cx="1415325" cy="1554480"/>
            <a:chOff x="2390310" y="2696727"/>
            <a:chExt cx="1906997" cy="2103120"/>
          </a:xfrm>
        </p:grpSpPr>
        <p:graphicFrame>
          <p:nvGraphicFramePr>
            <p:cNvPr id="60" name="Chart 5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03262210"/>
                </p:ext>
              </p:extLst>
            </p:nvPr>
          </p:nvGraphicFramePr>
          <p:xfrm>
            <a:off x="2390310" y="2696727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1" name="TextBox 60"/>
            <p:cNvSpPr txBox="1"/>
            <p:nvPr/>
          </p:nvSpPr>
          <p:spPr>
            <a:xfrm>
              <a:off x="3057304" y="3302114"/>
              <a:ext cx="425928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467095" y="3824096"/>
              <a:ext cx="425928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871379" y="3874128"/>
              <a:ext cx="425928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756958" y="3190732"/>
              <a:ext cx="425928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3238833" y="1447800"/>
            <a:ext cx="1371600" cy="1554480"/>
            <a:chOff x="4295310" y="2696727"/>
            <a:chExt cx="1857150" cy="2103120"/>
          </a:xfrm>
        </p:grpSpPr>
        <p:graphicFrame>
          <p:nvGraphicFramePr>
            <p:cNvPr id="66" name="Chart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3187576"/>
                </p:ext>
              </p:extLst>
            </p:nvPr>
          </p:nvGraphicFramePr>
          <p:xfrm>
            <a:off x="4295310" y="2696727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7" name="TextBox 66"/>
            <p:cNvSpPr txBox="1"/>
            <p:nvPr/>
          </p:nvSpPr>
          <p:spPr>
            <a:xfrm>
              <a:off x="5030286" y="3266848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440078" y="3962400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844362" y="4012432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729941" y="3155466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</p:grpSp>
      <p:sp>
        <p:nvSpPr>
          <p:cNvPr id="71" name="TextBox 70"/>
          <p:cNvSpPr txBox="1"/>
          <p:nvPr/>
        </p:nvSpPr>
        <p:spPr>
          <a:xfrm>
            <a:off x="1072553" y="1448079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● DMSO</a:t>
            </a:r>
          </a:p>
          <a:p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■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 µM VE821</a:t>
            </a:r>
            <a:endParaRPr 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2" name="Group 71"/>
          <p:cNvGrpSpPr/>
          <p:nvPr/>
        </p:nvGrpSpPr>
        <p:grpSpPr>
          <a:xfrm>
            <a:off x="398363" y="3998052"/>
            <a:ext cx="1371600" cy="1554480"/>
            <a:chOff x="491917" y="6935585"/>
            <a:chExt cx="1828800" cy="2103120"/>
          </a:xfrm>
        </p:grpSpPr>
        <p:graphicFrame>
          <p:nvGraphicFramePr>
            <p:cNvPr id="73" name="Chart 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59248552"/>
                </p:ext>
              </p:extLst>
            </p:nvPr>
          </p:nvGraphicFramePr>
          <p:xfrm>
            <a:off x="491917" y="6935585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4" name="TextBox 73"/>
            <p:cNvSpPr txBox="1"/>
            <p:nvPr/>
          </p:nvSpPr>
          <p:spPr>
            <a:xfrm>
              <a:off x="879094" y="7316646"/>
              <a:ext cx="30809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166554" y="7397600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575262" y="7467600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026500" y="7519122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3241129" y="3998052"/>
            <a:ext cx="1371600" cy="1554480"/>
            <a:chOff x="4299095" y="6935585"/>
            <a:chExt cx="1853365" cy="2103120"/>
          </a:xfrm>
        </p:grpSpPr>
        <p:graphicFrame>
          <p:nvGraphicFramePr>
            <p:cNvPr id="79" name="Chart 7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67265133"/>
                </p:ext>
              </p:extLst>
            </p:nvPr>
          </p:nvGraphicFramePr>
          <p:xfrm>
            <a:off x="4299095" y="6935585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80" name="TextBox 79"/>
            <p:cNvSpPr txBox="1"/>
            <p:nvPr/>
          </p:nvSpPr>
          <p:spPr>
            <a:xfrm>
              <a:off x="5017938" y="7940997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5440078" y="8048719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844362" y="8048719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671820" y="7505322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1820546" y="4008120"/>
            <a:ext cx="1371600" cy="1554480"/>
            <a:chOff x="2396917" y="6932129"/>
            <a:chExt cx="1851924" cy="2103120"/>
          </a:xfrm>
        </p:grpSpPr>
        <p:graphicFrame>
          <p:nvGraphicFramePr>
            <p:cNvPr id="85" name="Chart 8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03320607"/>
                </p:ext>
              </p:extLst>
            </p:nvPr>
          </p:nvGraphicFramePr>
          <p:xfrm>
            <a:off x="2396917" y="6932129"/>
            <a:ext cx="182880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86" name="TextBox 85"/>
            <p:cNvSpPr txBox="1"/>
            <p:nvPr/>
          </p:nvSpPr>
          <p:spPr>
            <a:xfrm>
              <a:off x="3129855" y="7511098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549462" y="7717527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940743" y="7765006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793604" y="7477662"/>
              <a:ext cx="3080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080875" y="4008120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● DMSO</a:t>
            </a:r>
          </a:p>
          <a:p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■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 µM VE821</a:t>
            </a:r>
            <a:endParaRPr 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4" name="Group 233"/>
          <p:cNvGrpSpPr/>
          <p:nvPr/>
        </p:nvGrpSpPr>
        <p:grpSpPr>
          <a:xfrm>
            <a:off x="380684" y="609600"/>
            <a:ext cx="3657916" cy="791289"/>
            <a:chOff x="409668" y="3059329"/>
            <a:chExt cx="3657916" cy="791289"/>
          </a:xfrm>
        </p:grpSpPr>
        <p:sp>
          <p:nvSpPr>
            <p:cNvPr id="211" name="TextBox 210"/>
            <p:cNvSpPr txBox="1"/>
            <p:nvPr/>
          </p:nvSpPr>
          <p:spPr>
            <a:xfrm>
              <a:off x="635967" y="3235475"/>
              <a:ext cx="413319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462862" y="3429000"/>
              <a:ext cx="5902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µM VE821</a:t>
              </a: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409668" y="3059329"/>
              <a:ext cx="65729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AUY922 (</a:t>
              </a:r>
              <a:r>
                <a:rPr lang="en-US" sz="60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1032294" y="305969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1214910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1444774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1659221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1904503" y="305969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2087120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2316984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2531431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2779245" y="305969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2961862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3191726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3406173" y="305932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3649480" y="3321503"/>
              <a:ext cx="418104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WE-68</a:t>
              </a:r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1313686" y="3666921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2183603" y="3666921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8 h</a:t>
              </a:r>
            </a:p>
          </p:txBody>
        </p:sp>
        <p:sp>
          <p:nvSpPr>
            <p:cNvPr id="230" name="TextBox 229"/>
            <p:cNvSpPr txBox="1"/>
            <p:nvPr/>
          </p:nvSpPr>
          <p:spPr>
            <a:xfrm>
              <a:off x="3049948" y="3657600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72 h</a:t>
              </a:r>
            </a:p>
          </p:txBody>
        </p:sp>
        <p:pic>
          <p:nvPicPr>
            <p:cNvPr id="231" name="Picture 230"/>
            <p:cNvPicPr>
              <a:picLocks noChangeAspect="1"/>
            </p:cNvPicPr>
            <p:nvPr/>
          </p:nvPicPr>
          <p:blipFill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37392" y="3216439"/>
              <a:ext cx="864000" cy="441161"/>
            </a:xfrm>
            <a:prstGeom prst="rect">
              <a:avLst/>
            </a:prstGeom>
          </p:spPr>
        </p:pic>
        <p:pic>
          <p:nvPicPr>
            <p:cNvPr id="232" name="Picture 231"/>
            <p:cNvPicPr>
              <a:picLocks noChangeAspect="1"/>
            </p:cNvPicPr>
            <p:nvPr/>
          </p:nvPicPr>
          <p:blipFill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08184" y="3216439"/>
              <a:ext cx="864000" cy="441161"/>
            </a:xfrm>
            <a:prstGeom prst="rect">
              <a:avLst/>
            </a:prstGeom>
          </p:spPr>
        </p:pic>
        <p:pic>
          <p:nvPicPr>
            <p:cNvPr id="233" name="Picture 232"/>
            <p:cNvPicPr>
              <a:picLocks noChangeAspect="1"/>
            </p:cNvPicPr>
            <p:nvPr/>
          </p:nvPicPr>
          <p:blipFill>
            <a:blip r:embed="rId12" cstate="hq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87117" y="3216439"/>
              <a:ext cx="864000" cy="441161"/>
            </a:xfrm>
            <a:prstGeom prst="rect">
              <a:avLst/>
            </a:prstGeom>
          </p:spPr>
        </p:pic>
      </p:grpSp>
      <p:sp>
        <p:nvSpPr>
          <p:cNvPr id="258" name="TextBox 257"/>
          <p:cNvSpPr txBox="1"/>
          <p:nvPr/>
        </p:nvSpPr>
        <p:spPr>
          <a:xfrm>
            <a:off x="152400" y="309356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62" name="Group 261"/>
          <p:cNvGrpSpPr/>
          <p:nvPr/>
        </p:nvGrpSpPr>
        <p:grpSpPr>
          <a:xfrm>
            <a:off x="398413" y="3205825"/>
            <a:ext cx="3605618" cy="791289"/>
            <a:chOff x="964184" y="3666799"/>
            <a:chExt cx="3605618" cy="791289"/>
          </a:xfrm>
        </p:grpSpPr>
        <p:sp>
          <p:nvSpPr>
            <p:cNvPr id="236" name="TextBox 235"/>
            <p:cNvSpPr txBox="1"/>
            <p:nvPr/>
          </p:nvSpPr>
          <p:spPr>
            <a:xfrm>
              <a:off x="1190483" y="3842945"/>
              <a:ext cx="413319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1017378" y="4036470"/>
              <a:ext cx="5902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µM VE821</a:t>
              </a:r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964184" y="3666799"/>
              <a:ext cx="65729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AUY922 (</a:t>
              </a:r>
              <a:r>
                <a:rPr lang="en-US" sz="60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1586810" y="366716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1769426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1999290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2213737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2459019" y="366716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2641636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2871500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3085947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3333761" y="3667161"/>
              <a:ext cx="226753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3516378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3746242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3960689" y="3666799"/>
              <a:ext cx="269806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4203996" y="3928973"/>
              <a:ext cx="3658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673</a:t>
              </a: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1868202" y="4274391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2738119" y="4274391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48 h</a:t>
              </a: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3604464" y="4265070"/>
              <a:ext cx="333590" cy="183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72 h</a:t>
              </a:r>
            </a:p>
          </p:txBody>
        </p:sp>
        <p:pic>
          <p:nvPicPr>
            <p:cNvPr id="259" name="Picture 258"/>
            <p:cNvPicPr>
              <a:picLocks noChangeAspect="1"/>
            </p:cNvPicPr>
            <p:nvPr/>
          </p:nvPicPr>
          <p:blipFill>
            <a:blip r:embed="rId14" cstate="hq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91888" y="3833196"/>
              <a:ext cx="864000" cy="434004"/>
            </a:xfrm>
            <a:prstGeom prst="rect">
              <a:avLst/>
            </a:prstGeom>
          </p:spPr>
        </p:pic>
        <p:pic>
          <p:nvPicPr>
            <p:cNvPr id="260" name="Picture 259"/>
            <p:cNvPicPr>
              <a:picLocks noChangeAspect="1"/>
            </p:cNvPicPr>
            <p:nvPr/>
          </p:nvPicPr>
          <p:blipFill>
            <a:blip r:embed="rId16" cstate="hq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69951" y="3828034"/>
              <a:ext cx="864000" cy="443553"/>
            </a:xfrm>
            <a:prstGeom prst="rect">
              <a:avLst/>
            </a:prstGeom>
          </p:spPr>
        </p:pic>
        <p:pic>
          <p:nvPicPr>
            <p:cNvPr id="261" name="Picture 260"/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42280" y="3828034"/>
              <a:ext cx="864000" cy="437036"/>
            </a:xfrm>
            <a:prstGeom prst="rect">
              <a:avLst/>
            </a:prstGeom>
          </p:spPr>
        </p:pic>
      </p:grpSp>
      <p:sp>
        <p:nvSpPr>
          <p:cNvPr id="91" name="Rechteck 2">
            <a:extLst>
              <a:ext uri="{FF2B5EF4-FFF2-40B4-BE49-F238E27FC236}">
                <a16:creationId xmlns="" xmlns:a16="http://schemas.microsoft.com/office/drawing/2014/main" id="{6EA42183-5913-EB44-A8C4-79B4AA26EDBB}"/>
              </a:ext>
            </a:extLst>
          </p:cNvPr>
          <p:cNvSpPr/>
          <p:nvPr/>
        </p:nvSpPr>
        <p:spPr>
          <a:xfrm>
            <a:off x="267617" y="5791200"/>
            <a:ext cx="625460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WE-68 and (B) 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5-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f AUY922, 5 µM of VE821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72 h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quantifi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rysta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ole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A-B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± SEM  of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5; 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1; **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01)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48818" y="50064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2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4967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0</Words>
  <Application>Microsoft Office PowerPoint</Application>
  <PresentationFormat>A4-Papier (210x297 mm)</PresentationFormat>
  <Paragraphs>9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9:32Z</dcterms:modified>
</cp:coreProperties>
</file>